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98CFF"/>
    <a:srgbClr val="3399FF"/>
    <a:srgbClr val="00C49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 showGuides="1">
      <p:cViewPr varScale="1">
        <p:scale>
          <a:sx n="155" d="100"/>
          <a:sy n="155" d="100"/>
        </p:scale>
        <p:origin x="384" y="1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B8C67-321F-41BF-BF01-EF9726654BB5}" type="datetimeFigureOut">
              <a:rPr lang="en-GB" smtClean="0"/>
              <a:t>2021-03-3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7F554-4562-4D9A-A805-50180FF18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5789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B8C67-321F-41BF-BF01-EF9726654BB5}" type="datetimeFigureOut">
              <a:rPr lang="en-GB" smtClean="0"/>
              <a:t>2021-03-3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7F554-4562-4D9A-A805-50180FF18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5159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B8C67-321F-41BF-BF01-EF9726654BB5}" type="datetimeFigureOut">
              <a:rPr lang="en-GB" smtClean="0"/>
              <a:t>2021-03-3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7F554-4562-4D9A-A805-50180FF18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0214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B8C67-321F-41BF-BF01-EF9726654BB5}" type="datetimeFigureOut">
              <a:rPr lang="en-GB" smtClean="0"/>
              <a:t>2021-03-3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7F554-4562-4D9A-A805-50180FF18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1950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B8C67-321F-41BF-BF01-EF9726654BB5}" type="datetimeFigureOut">
              <a:rPr lang="en-GB" smtClean="0"/>
              <a:t>2021-03-3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7F554-4562-4D9A-A805-50180FF18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57050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B8C67-321F-41BF-BF01-EF9726654BB5}" type="datetimeFigureOut">
              <a:rPr lang="en-GB" smtClean="0"/>
              <a:t>2021-03-3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7F554-4562-4D9A-A805-50180FF18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4717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B8C67-321F-41BF-BF01-EF9726654BB5}" type="datetimeFigureOut">
              <a:rPr lang="en-GB" smtClean="0"/>
              <a:t>2021-03-3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7F554-4562-4D9A-A805-50180FF18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57179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B8C67-321F-41BF-BF01-EF9726654BB5}" type="datetimeFigureOut">
              <a:rPr lang="en-GB" smtClean="0"/>
              <a:t>2021-03-3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7F554-4562-4D9A-A805-50180FF18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91025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B8C67-321F-41BF-BF01-EF9726654BB5}" type="datetimeFigureOut">
              <a:rPr lang="en-GB" smtClean="0"/>
              <a:t>2021-03-3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7F554-4562-4D9A-A805-50180FF18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04808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B8C67-321F-41BF-BF01-EF9726654BB5}" type="datetimeFigureOut">
              <a:rPr lang="en-GB" smtClean="0"/>
              <a:t>2021-03-3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7F554-4562-4D9A-A805-50180FF18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55735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B8C67-321F-41BF-BF01-EF9726654BB5}" type="datetimeFigureOut">
              <a:rPr lang="en-GB" smtClean="0"/>
              <a:t>2021-03-3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7F554-4562-4D9A-A805-50180FF18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71342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EB8C67-321F-41BF-BF01-EF9726654BB5}" type="datetimeFigureOut">
              <a:rPr lang="en-GB" smtClean="0"/>
              <a:t>2021-03-3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F7F554-4562-4D9A-A805-50180FF18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91406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29746" y="6023919"/>
            <a:ext cx="75129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 smtClean="0"/>
              <a:t>Supplementary Figure 1: Validation of the pharmacophore model</a:t>
            </a:r>
            <a:endParaRPr lang="en-GB" sz="1600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905" r="9037" b="13962"/>
          <a:stretch/>
        </p:blipFill>
        <p:spPr>
          <a:xfrm>
            <a:off x="963826" y="605480"/>
            <a:ext cx="8451631" cy="37997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84875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51145" y="6239321"/>
            <a:ext cx="81727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 smtClean="0"/>
              <a:t>Supplementary Figure 2: Mapping of the virtually screened compounds from </a:t>
            </a:r>
            <a:r>
              <a:rPr lang="en-GB" sz="1600" b="1" dirty="0" err="1" smtClean="0"/>
              <a:t>DrugBank</a:t>
            </a:r>
            <a:r>
              <a:rPr lang="en-GB" sz="1600" b="1" dirty="0" smtClean="0"/>
              <a:t>.</a:t>
            </a:r>
            <a:endParaRPr lang="en-GB" sz="1600" b="1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87221"/>
            <a:ext cx="3861881" cy="1723431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729229" y="2850871"/>
            <a:ext cx="3385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-</a:t>
            </a:r>
            <a:r>
              <a:rPr lang="en-GB" dirty="0" err="1" smtClean="0"/>
              <a:t>adenosylmethionine</a:t>
            </a:r>
            <a:endParaRPr lang="en-GB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5462" y="799939"/>
            <a:ext cx="3891993" cy="1697994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4403388" y="2850871"/>
            <a:ext cx="3385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Tobramycin</a:t>
            </a:r>
            <a:endParaRPr lang="en-GB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43141" y="872432"/>
            <a:ext cx="3501957" cy="1568453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9040239" y="2850871"/>
            <a:ext cx="3385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Framycetin</a:t>
            </a:r>
            <a:endParaRPr lang="en-GB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980" y="3993655"/>
            <a:ext cx="4086885" cy="1810193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1018164" y="5809621"/>
            <a:ext cx="3385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Kanamycin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713649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8699" y="236057"/>
            <a:ext cx="8824757" cy="5043353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580846" y="5935300"/>
            <a:ext cx="1089228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b="1" dirty="0"/>
              <a:t>Supplementary Figure </a:t>
            </a:r>
            <a:r>
              <a:rPr lang="en-GB" b="1" dirty="0" smtClean="0"/>
              <a:t>3: RMSF of the active site residues. A) Active site residues around the cocrystallised ligand SAM. B) RMSF plot of the residues. Green box indicates the active site residues.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36364602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0760" y="313673"/>
            <a:ext cx="10437779" cy="4900877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3791680" y="242949"/>
            <a:ext cx="7681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6W4H</a:t>
            </a:r>
          </a:p>
        </p:txBody>
      </p:sp>
      <p:sp>
        <p:nvSpPr>
          <p:cNvPr id="8" name="Rectangle 7"/>
          <p:cNvSpPr/>
          <p:nvPr/>
        </p:nvSpPr>
        <p:spPr>
          <a:xfrm>
            <a:off x="3372131" y="338864"/>
            <a:ext cx="494852" cy="177501"/>
          </a:xfrm>
          <a:prstGeom prst="rect">
            <a:avLst/>
          </a:prstGeom>
          <a:solidFill>
            <a:srgbClr val="00C49F"/>
          </a:solidFill>
          <a:ln>
            <a:solidFill>
              <a:srgbClr val="00C49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rgbClr val="00C49F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3372131" y="571489"/>
            <a:ext cx="494852" cy="177501"/>
          </a:xfrm>
          <a:prstGeom prst="rect">
            <a:avLst/>
          </a:prstGeom>
          <a:solidFill>
            <a:srgbClr val="198C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rgbClr val="00C49F"/>
              </a:solidFill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3791680" y="475573"/>
            <a:ext cx="66075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3R24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738627" y="-191521"/>
            <a:ext cx="113015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4000" b="1" dirty="0" smtClean="0"/>
              <a:t>A</a:t>
            </a:r>
            <a:endParaRPr lang="en-GB" sz="40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4893142" y="-191521"/>
            <a:ext cx="86974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4000" b="1" dirty="0"/>
              <a:t>B</a:t>
            </a:r>
          </a:p>
        </p:txBody>
      </p:sp>
      <p:sp>
        <p:nvSpPr>
          <p:cNvPr id="10" name="Rectangle 9"/>
          <p:cNvSpPr/>
          <p:nvPr/>
        </p:nvSpPr>
        <p:spPr>
          <a:xfrm>
            <a:off x="580846" y="5935300"/>
            <a:ext cx="1089228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b="1" dirty="0"/>
              <a:t>Supplementary Figure 4</a:t>
            </a:r>
            <a:r>
              <a:rPr lang="en-GB" b="1" dirty="0" smtClean="0"/>
              <a:t>: Alignment of SARS- </a:t>
            </a:r>
            <a:r>
              <a:rPr lang="en-GB" b="1" dirty="0" err="1" smtClean="0"/>
              <a:t>CoV</a:t>
            </a:r>
            <a:r>
              <a:rPr lang="en-GB" b="1" dirty="0" smtClean="0"/>
              <a:t> and </a:t>
            </a:r>
            <a:r>
              <a:rPr lang="en-GB" b="1" dirty="0"/>
              <a:t>SARS- </a:t>
            </a:r>
            <a:r>
              <a:rPr lang="en-GB" b="1" dirty="0" smtClean="0"/>
              <a:t>CoV-2. A) Superimposition of the structures . B) Sequence alignment between </a:t>
            </a:r>
            <a:r>
              <a:rPr lang="en-GB" b="1" dirty="0"/>
              <a:t>SARS- </a:t>
            </a:r>
            <a:r>
              <a:rPr lang="en-GB" b="1" dirty="0" err="1"/>
              <a:t>CoV</a:t>
            </a:r>
            <a:r>
              <a:rPr lang="en-GB" b="1" dirty="0"/>
              <a:t> and SARS- CoV-2</a:t>
            </a:r>
            <a:r>
              <a:rPr lang="en-GB" b="1" dirty="0" smtClean="0"/>
              <a:t> .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11389063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5373" y="920035"/>
            <a:ext cx="5193276" cy="4643521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049759" y="6311216"/>
            <a:ext cx="7985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Supplementary Figure </a:t>
            </a:r>
            <a:r>
              <a:rPr lang="en-GB" b="1" dirty="0" smtClean="0"/>
              <a:t>5:  2D interaction map of putative inhibitors and references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27983" y="943493"/>
            <a:ext cx="6127382" cy="45966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81873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</TotalTime>
  <Words>110</Words>
  <Application>Microsoft Office PowerPoint</Application>
  <PresentationFormat>Widescreen</PresentationFormat>
  <Paragraphs>1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ma</dc:creator>
  <cp:lastModifiedBy>Lima</cp:lastModifiedBy>
  <cp:revision>11</cp:revision>
  <dcterms:created xsi:type="dcterms:W3CDTF">2020-09-16T06:18:48Z</dcterms:created>
  <dcterms:modified xsi:type="dcterms:W3CDTF">2021-03-31T05:53:36Z</dcterms:modified>
</cp:coreProperties>
</file>